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D40F46-0F85-4CCD-8F86-CBC74C1F24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24F24B-FEE6-44EE-8990-6E34A83299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2DB6F-EA58-4DC4-9BF8-7D62848D1C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56F3E-B09C-450F-BE2A-26DC71973F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193C6-10DD-4440-9693-959BA3A330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9FD8C8-BA45-4D26-AFB4-6914FEBF54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01F020-C1DB-471E-AF06-E3C7DC6D91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902EA-0468-4C9F-84B8-578832ACB0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0021D5-BB17-47CE-A334-24599893F4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11284-23A5-4644-8170-4D67909B2C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D8A102-A8EF-4482-B322-4231554C7E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D4C30-46FB-4376-9FBE-B9607E623A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348B3D-4A7F-4AA8-BCDE-6C33B6ABD5F9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1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4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42"/>
          <p:cNvGrpSpPr/>
          <p:nvPr/>
        </p:nvGrpSpPr>
        <p:grpSpPr>
          <a:xfrm>
            <a:off x="1440" y="0"/>
            <a:ext cx="9004320" cy="6640200"/>
            <a:chOff x="1440" y="0"/>
            <a:chExt cx="9004320" cy="6640200"/>
          </a:xfrm>
        </p:grpSpPr>
        <p:grpSp>
          <p:nvGrpSpPr>
            <p:cNvPr id="42" name="Groupe 37"/>
            <p:cNvGrpSpPr/>
            <p:nvPr/>
          </p:nvGrpSpPr>
          <p:grpSpPr>
            <a:xfrm>
              <a:off x="1440" y="3584520"/>
              <a:ext cx="8886240" cy="3055680"/>
              <a:chOff x="1440" y="3584520"/>
              <a:chExt cx="8886240" cy="3055680"/>
            </a:xfrm>
          </p:grpSpPr>
          <p:sp>
            <p:nvSpPr>
              <p:cNvPr id="43" name="Accolade ouvrante 2"/>
              <p:cNvSpPr/>
              <p:nvPr/>
            </p:nvSpPr>
            <p:spPr>
              <a:xfrm>
                <a:off x="2698560" y="3749760"/>
                <a:ext cx="504720" cy="2016360"/>
              </a:xfrm>
              <a:custGeom>
                <a:avLst/>
                <a:gdLst>
                  <a:gd name="textAreaLeft" fmla="*/ 322560 w 504720"/>
                  <a:gd name="textAreaRight" fmla="*/ 505080 w 504720"/>
                  <a:gd name="textAreaTop" fmla="*/ 12960 h 2016360"/>
                  <a:gd name="textAreaBottom" fmla="*/ 2003400 h 20163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226"/>
                      <a:pt x="10800" y="451"/>
                    </a:cubicBezTo>
                    <a:lnTo>
                      <a:pt x="10800" y="10349"/>
                    </a:lnTo>
                    <a:cubicBezTo>
                      <a:pt x="10800" y="10575"/>
                      <a:pt x="5400" y="10800"/>
                      <a:pt x="0" y="10800"/>
                    </a:cubicBezTo>
                    <a:cubicBezTo>
                      <a:pt x="5400" y="10800"/>
                      <a:pt x="10800" y="11026"/>
                      <a:pt x="10800" y="11251"/>
                    </a:cubicBezTo>
                    <a:lnTo>
                      <a:pt x="10800" y="21149"/>
                    </a:lnTo>
                    <a:cubicBezTo>
                      <a:pt x="10800" y="21375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44" name="Picture 12" descr=""/>
              <p:cNvPicPr/>
              <p:nvPr/>
            </p:nvPicPr>
            <p:blipFill>
              <a:blip r:embed="rId1"/>
              <a:srcRect l="0" t="53833" r="35117" b="0"/>
              <a:stretch/>
            </p:blipFill>
            <p:spPr>
              <a:xfrm>
                <a:off x="3168000" y="4838760"/>
                <a:ext cx="5091120" cy="1008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2" descr=""/>
              <p:cNvPicPr/>
              <p:nvPr/>
            </p:nvPicPr>
            <p:blipFill>
              <a:blip r:embed="rId2"/>
              <a:srcRect l="0" t="0" r="4345" b="5690"/>
              <a:stretch/>
            </p:blipFill>
            <p:spPr>
              <a:xfrm>
                <a:off x="1440" y="4219920"/>
                <a:ext cx="2735640" cy="1778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12" descr=""/>
              <p:cNvPicPr/>
              <p:nvPr/>
            </p:nvPicPr>
            <p:blipFill>
              <a:blip r:embed="rId3"/>
              <a:srcRect l="32941" t="0" r="0" b="56943"/>
              <a:stretch/>
            </p:blipFill>
            <p:spPr>
              <a:xfrm>
                <a:off x="3247200" y="3693960"/>
                <a:ext cx="5640480" cy="1008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Connecteur droit 6"/>
              <p:cNvSpPr/>
              <p:nvPr/>
            </p:nvSpPr>
            <p:spPr>
              <a:xfrm>
                <a:off x="3270240" y="3967200"/>
                <a:ext cx="360360" cy="0"/>
              </a:xfrm>
              <a:prstGeom prst="line">
                <a:avLst/>
              </a:prstGeom>
              <a:ln w="57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Connecteur droit 7"/>
              <p:cNvSpPr/>
              <p:nvPr/>
            </p:nvSpPr>
            <p:spPr>
              <a:xfrm>
                <a:off x="3620880" y="3967200"/>
                <a:ext cx="4606920" cy="0"/>
              </a:xfrm>
              <a:prstGeom prst="line">
                <a:avLst/>
              </a:prstGeom>
              <a:ln w="57240">
                <a:solidFill>
                  <a:srgbClr val="4f81b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ZoneTexte 34"/>
              <p:cNvSpPr/>
              <p:nvPr/>
            </p:nvSpPr>
            <p:spPr>
              <a:xfrm>
                <a:off x="6943680" y="3584520"/>
                <a:ext cx="269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400" spc="-1" strike="noStrike">
                    <a:solidFill>
                      <a:srgbClr val="ff0000"/>
                    </a:solidFill>
                    <a:latin typeface="Calibri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Connecteur droit 9"/>
              <p:cNvSpPr/>
              <p:nvPr/>
            </p:nvSpPr>
            <p:spPr>
              <a:xfrm>
                <a:off x="3252600" y="5139000"/>
                <a:ext cx="703080" cy="0"/>
              </a:xfrm>
              <a:prstGeom prst="line">
                <a:avLst/>
              </a:prstGeom>
              <a:ln w="57240">
                <a:solidFill>
                  <a:srgbClr val="ffc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Connecteur droit 10"/>
              <p:cNvSpPr/>
              <p:nvPr/>
            </p:nvSpPr>
            <p:spPr>
              <a:xfrm>
                <a:off x="8209080" y="3967200"/>
                <a:ext cx="647640" cy="0"/>
              </a:xfrm>
              <a:prstGeom prst="line">
                <a:avLst/>
              </a:prstGeom>
              <a:ln w="57240">
                <a:solidFill>
                  <a:srgbClr val="ffc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Connecteur droit 11"/>
              <p:cNvSpPr/>
              <p:nvPr/>
            </p:nvSpPr>
            <p:spPr>
              <a:xfrm>
                <a:off x="3960720" y="5135760"/>
                <a:ext cx="3995640" cy="0"/>
              </a:xfrm>
              <a:prstGeom prst="line">
                <a:avLst/>
              </a:prstGeom>
              <a:ln w="57240">
                <a:solidFill>
                  <a:srgbClr val="00b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Connecteur droit 12"/>
              <p:cNvSpPr/>
              <p:nvPr/>
            </p:nvSpPr>
            <p:spPr>
              <a:xfrm>
                <a:off x="7912080" y="5135760"/>
                <a:ext cx="360360" cy="0"/>
              </a:xfrm>
              <a:prstGeom prst="line">
                <a:avLst/>
              </a:prstGeom>
              <a:ln w="57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Connecteur droit 13"/>
              <p:cNvSpPr/>
              <p:nvPr/>
            </p:nvSpPr>
            <p:spPr>
              <a:xfrm>
                <a:off x="3241440" y="5972400"/>
                <a:ext cx="215640" cy="0"/>
              </a:xfrm>
              <a:prstGeom prst="line">
                <a:avLst/>
              </a:prstGeom>
              <a:ln w="57240">
                <a:solidFill>
                  <a:srgbClr val="4f81b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Connecteur droit 14"/>
              <p:cNvSpPr/>
              <p:nvPr/>
            </p:nvSpPr>
            <p:spPr>
              <a:xfrm>
                <a:off x="3243240" y="6151680"/>
                <a:ext cx="215640" cy="0"/>
              </a:xfrm>
              <a:prstGeom prst="line">
                <a:avLst/>
              </a:prstGeom>
              <a:ln w="57240">
                <a:solidFill>
                  <a:srgbClr val="00b05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Connecteur droit 15"/>
              <p:cNvSpPr/>
              <p:nvPr/>
            </p:nvSpPr>
            <p:spPr>
              <a:xfrm>
                <a:off x="3241440" y="6332760"/>
                <a:ext cx="215640" cy="0"/>
              </a:xfrm>
              <a:prstGeom prst="line">
                <a:avLst/>
              </a:prstGeom>
              <a:ln w="57240">
                <a:solidFill>
                  <a:srgbClr val="ffc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Connecteur droit 16"/>
              <p:cNvSpPr/>
              <p:nvPr/>
            </p:nvSpPr>
            <p:spPr>
              <a:xfrm>
                <a:off x="3241440" y="6521760"/>
                <a:ext cx="215640" cy="0"/>
              </a:xfrm>
              <a:prstGeom prst="line">
                <a:avLst/>
              </a:prstGeom>
              <a:ln w="57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ZoneTexte 21"/>
              <p:cNvSpPr/>
              <p:nvPr/>
            </p:nvSpPr>
            <p:spPr>
              <a:xfrm>
                <a:off x="3485520" y="5816160"/>
                <a:ext cx="3399480" cy="8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equence with the R248C </a:t>
                </a:r>
                <a:r>
                  <a:rPr b="0" i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GFR3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utation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(C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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</a:t>
                </a:r>
                <a:r>
                  <a:rPr b="0" lang="fr-FR" sz="1200" spc="-1" strike="noStrike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*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equence with the G372C </a:t>
                </a:r>
                <a:r>
                  <a:rPr b="0" i="1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GFR3 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utation (G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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</a:t>
                </a:r>
                <a:r>
                  <a:rPr b="0" lang="fr-FR" sz="1200" spc="-1" strike="noStrike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*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P6 promoter sequence (linker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coR1 restriction sit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ZoneTexte 34"/>
              <p:cNvSpPr/>
              <p:nvPr/>
            </p:nvSpPr>
            <p:spPr>
              <a:xfrm>
                <a:off x="6265800" y="4729320"/>
                <a:ext cx="269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400" spc="-1" strike="noStrike">
                    <a:solidFill>
                      <a:srgbClr val="ff0000"/>
                    </a:solidFill>
                    <a:latin typeface="Calibri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0" name="Groupe 40"/>
            <p:cNvGrpSpPr/>
            <p:nvPr/>
          </p:nvGrpSpPr>
          <p:grpSpPr>
            <a:xfrm>
              <a:off x="35640" y="280800"/>
              <a:ext cx="8970120" cy="3046320"/>
              <a:chOff x="35640" y="280800"/>
              <a:chExt cx="8970120" cy="3046320"/>
            </a:xfrm>
          </p:grpSpPr>
          <p:pic>
            <p:nvPicPr>
              <p:cNvPr id="61" name="Picture 8" descr=""/>
              <p:cNvPicPr/>
              <p:nvPr/>
            </p:nvPicPr>
            <p:blipFill>
              <a:blip r:embed="rId4"/>
              <a:srcRect l="2881" t="0" r="3929" b="0"/>
              <a:stretch/>
            </p:blipFill>
            <p:spPr>
              <a:xfrm>
                <a:off x="35640" y="893520"/>
                <a:ext cx="2664000" cy="1938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2" name="Picture 7" descr=""/>
              <p:cNvPicPr/>
              <p:nvPr/>
            </p:nvPicPr>
            <p:blipFill>
              <a:blip r:embed="rId5"/>
              <a:srcRect l="32111" t="0" r="0" b="70666"/>
              <a:stretch/>
            </p:blipFill>
            <p:spPr>
              <a:xfrm>
                <a:off x="3303720" y="389520"/>
                <a:ext cx="5385960" cy="1007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63" name="Picture 7" descr=""/>
              <p:cNvPicPr/>
              <p:nvPr/>
            </p:nvPicPr>
            <p:blipFill>
              <a:blip r:embed="rId6"/>
              <a:srcRect l="0" t="32142" r="27450" b="29342"/>
              <a:stretch/>
            </p:blipFill>
            <p:spPr>
              <a:xfrm>
                <a:off x="3224520" y="1419120"/>
                <a:ext cx="5781240" cy="1328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4" name="Connecteur droit 23"/>
              <p:cNvSpPr/>
              <p:nvPr/>
            </p:nvSpPr>
            <p:spPr>
              <a:xfrm>
                <a:off x="3365280" y="647640"/>
                <a:ext cx="317520" cy="0"/>
              </a:xfrm>
              <a:prstGeom prst="line">
                <a:avLst/>
              </a:prstGeom>
              <a:ln w="57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Connecteur droit 24"/>
              <p:cNvSpPr/>
              <p:nvPr/>
            </p:nvSpPr>
            <p:spPr>
              <a:xfrm>
                <a:off x="8610480" y="1792440"/>
                <a:ext cx="336240" cy="0"/>
              </a:xfrm>
              <a:prstGeom prst="line">
                <a:avLst/>
              </a:prstGeom>
              <a:ln w="57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Connecteur droit 25"/>
              <p:cNvSpPr/>
              <p:nvPr/>
            </p:nvSpPr>
            <p:spPr>
              <a:xfrm>
                <a:off x="3676320" y="647640"/>
                <a:ext cx="4605480" cy="0"/>
              </a:xfrm>
              <a:prstGeom prst="line">
                <a:avLst/>
              </a:prstGeom>
              <a:ln w="57240">
                <a:solidFill>
                  <a:srgbClr val="00206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ZoneTexte 10"/>
              <p:cNvSpPr/>
              <p:nvPr/>
            </p:nvSpPr>
            <p:spPr>
              <a:xfrm>
                <a:off x="7029000" y="280800"/>
                <a:ext cx="269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400" spc="-1" strike="noStrike">
                    <a:solidFill>
                      <a:srgbClr val="ff0000"/>
                    </a:solidFill>
                    <a:latin typeface="Calibri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Connecteur droit 27"/>
              <p:cNvSpPr/>
              <p:nvPr/>
            </p:nvSpPr>
            <p:spPr>
              <a:xfrm>
                <a:off x="8242200" y="647640"/>
                <a:ext cx="395280" cy="0"/>
              </a:xfrm>
              <a:prstGeom prst="line">
                <a:avLst/>
              </a:prstGeom>
              <a:ln w="57240">
                <a:solidFill>
                  <a:srgbClr val="ffc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Connecteur droit 28"/>
              <p:cNvSpPr/>
              <p:nvPr/>
            </p:nvSpPr>
            <p:spPr>
              <a:xfrm>
                <a:off x="3284280" y="1795680"/>
                <a:ext cx="911160" cy="0"/>
              </a:xfrm>
              <a:prstGeom prst="line">
                <a:avLst/>
              </a:prstGeom>
              <a:ln w="57240">
                <a:solidFill>
                  <a:srgbClr val="ffc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Connecteur droit 29"/>
              <p:cNvSpPr/>
              <p:nvPr/>
            </p:nvSpPr>
            <p:spPr>
              <a:xfrm>
                <a:off x="4176360" y="1792440"/>
                <a:ext cx="4432320" cy="0"/>
              </a:xfrm>
              <a:prstGeom prst="line">
                <a:avLst/>
              </a:prstGeom>
              <a:ln w="572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ZoneTexte 14"/>
              <p:cNvSpPr/>
              <p:nvPr/>
            </p:nvSpPr>
            <p:spPr>
              <a:xfrm>
                <a:off x="7114320" y="1419120"/>
                <a:ext cx="2692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400" spc="-1" strike="noStrike">
                    <a:solidFill>
                      <a:srgbClr val="ff0000"/>
                    </a:solidFill>
                    <a:latin typeface="Calibri"/>
                  </a:rPr>
                  <a:t>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Accolade ouvrante 31"/>
              <p:cNvSpPr/>
              <p:nvPr/>
            </p:nvSpPr>
            <p:spPr>
              <a:xfrm>
                <a:off x="2722320" y="430200"/>
                <a:ext cx="504720" cy="2014560"/>
              </a:xfrm>
              <a:custGeom>
                <a:avLst/>
                <a:gdLst>
                  <a:gd name="textAreaLeft" fmla="*/ 322560 w 504720"/>
                  <a:gd name="textAreaRight" fmla="*/ 505080 w 504720"/>
                  <a:gd name="textAreaTop" fmla="*/ 12960 h 2014560"/>
                  <a:gd name="textAreaBottom" fmla="*/ 2001600 h 20145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226"/>
                      <a:pt x="10800" y="451"/>
                    </a:cubicBezTo>
                    <a:lnTo>
                      <a:pt x="10800" y="10349"/>
                    </a:lnTo>
                    <a:cubicBezTo>
                      <a:pt x="10800" y="10575"/>
                      <a:pt x="5400" y="10800"/>
                      <a:pt x="0" y="10800"/>
                    </a:cubicBezTo>
                    <a:cubicBezTo>
                      <a:pt x="5400" y="10800"/>
                      <a:pt x="10800" y="11026"/>
                      <a:pt x="10800" y="11251"/>
                    </a:cubicBezTo>
                    <a:lnTo>
                      <a:pt x="10800" y="21149"/>
                    </a:lnTo>
                    <a:cubicBezTo>
                      <a:pt x="10800" y="21375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4a7ebb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Connecteur droit 32"/>
              <p:cNvSpPr/>
              <p:nvPr/>
            </p:nvSpPr>
            <p:spPr>
              <a:xfrm>
                <a:off x="3265200" y="2646720"/>
                <a:ext cx="215640" cy="0"/>
              </a:xfrm>
              <a:prstGeom prst="line">
                <a:avLst/>
              </a:prstGeom>
              <a:ln w="57240">
                <a:solidFill>
                  <a:srgbClr val="00206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Connecteur droit 33"/>
              <p:cNvSpPr/>
              <p:nvPr/>
            </p:nvSpPr>
            <p:spPr>
              <a:xfrm>
                <a:off x="3266640" y="2827800"/>
                <a:ext cx="215640" cy="0"/>
              </a:xfrm>
              <a:prstGeom prst="line">
                <a:avLst/>
              </a:prstGeom>
              <a:ln w="57240">
                <a:solidFill>
                  <a:srgbClr val="00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Connecteur droit 34"/>
              <p:cNvSpPr/>
              <p:nvPr/>
            </p:nvSpPr>
            <p:spPr>
              <a:xfrm>
                <a:off x="3265200" y="3007080"/>
                <a:ext cx="215640" cy="0"/>
              </a:xfrm>
              <a:prstGeom prst="line">
                <a:avLst/>
              </a:prstGeom>
              <a:ln w="57240">
                <a:solidFill>
                  <a:srgbClr val="ffc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Connecteur droit 35"/>
              <p:cNvSpPr/>
              <p:nvPr/>
            </p:nvSpPr>
            <p:spPr>
              <a:xfrm>
                <a:off x="3265200" y="3196080"/>
                <a:ext cx="215640" cy="0"/>
              </a:xfrm>
              <a:prstGeom prst="line">
                <a:avLst/>
              </a:prstGeom>
              <a:ln w="5724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ZoneTexte 21"/>
              <p:cNvSpPr/>
              <p:nvPr/>
            </p:nvSpPr>
            <p:spPr>
              <a:xfrm>
                <a:off x="3545640" y="2503080"/>
                <a:ext cx="3454560" cy="824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equence with the S249C </a:t>
                </a:r>
                <a:r>
                  <a:rPr b="0" i="1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GFR3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mutation (C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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</a:t>
                </a:r>
                <a:r>
                  <a:rPr b="0" lang="fr-FR" sz="1200" spc="-1" strike="noStrike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*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equence with the  Y375C </a:t>
                </a:r>
                <a:r>
                  <a:rPr b="0" i="1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FGFR3 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utation (A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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G</a:t>
                </a:r>
                <a:r>
                  <a:rPr b="0" lang="fr-FR" sz="1200" spc="-1" strike="noStrike">
                    <a:solidFill>
                      <a:srgbClr val="ff0000"/>
                    </a:solidFill>
                    <a:latin typeface="Times New Roman"/>
                    <a:ea typeface="Times New Roman"/>
                  </a:rPr>
                  <a:t>*</a:t>
                </a: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P6 promoter sequence (linker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coR1 restriction sit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8" name="ZoneTexte 31"/>
            <p:cNvSpPr/>
            <p:nvPr/>
          </p:nvSpPr>
          <p:spPr>
            <a:xfrm>
              <a:off x="228240" y="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ZoneTexte 31"/>
            <p:cNvSpPr/>
            <p:nvPr/>
          </p:nvSpPr>
          <p:spPr>
            <a:xfrm>
              <a:off x="239400" y="332496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4-18T14:00:49Z</dcterms:created>
  <dc:creator>ROPERCH Jean-Pierre</dc:creator>
  <dc:description/>
  <dc:language>en-US</dc:language>
  <cp:lastModifiedBy>ROPERCH Jean-Pierre</cp:lastModifiedBy>
  <dcterms:modified xsi:type="dcterms:W3CDTF">2020-03-30T19:33:01Z</dcterms:modified>
  <cp:revision>10</cp:revision>
  <dc:subject/>
  <dc:title>Diapositive 1</dc:title>
</cp:coreProperties>
</file>